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957" autoAdjust="0"/>
    <p:restoredTop sz="88965" autoAdjust="0"/>
  </p:normalViewPr>
  <p:slideViewPr>
    <p:cSldViewPr snapToGrid="0">
      <p:cViewPr varScale="1">
        <p:scale>
          <a:sx n="66" d="100"/>
          <a:sy n="66" d="100"/>
        </p:scale>
        <p:origin x="7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袖野 美穂/SODENO Miho" userId="013d5c9f-92f5-4661-9e91-da806e7982b3" providerId="ADAL" clId="{BCEA33ED-80C8-45DA-84CA-E58B367BC6D5}"/>
    <pc:docChg chg="delSld">
      <pc:chgData name="袖野 美穂/SODENO Miho" userId="013d5c9f-92f5-4661-9e91-da806e7982b3" providerId="ADAL" clId="{BCEA33ED-80C8-45DA-84CA-E58B367BC6D5}" dt="2025-07-07T17:16:13.987" v="6" actId="47"/>
      <pc:docMkLst>
        <pc:docMk/>
      </pc:docMkLst>
      <pc:sldChg chg="del">
        <pc:chgData name="袖野 美穂/SODENO Miho" userId="013d5c9f-92f5-4661-9e91-da806e7982b3" providerId="ADAL" clId="{BCEA33ED-80C8-45DA-84CA-E58B367BC6D5}" dt="2025-07-07T17:16:10.363" v="1" actId="47"/>
        <pc:sldMkLst>
          <pc:docMk/>
          <pc:sldMk cId="2402741190" sldId="269"/>
        </pc:sldMkLst>
      </pc:sldChg>
      <pc:sldChg chg="del">
        <pc:chgData name="袖野 美穂/SODENO Miho" userId="013d5c9f-92f5-4661-9e91-da806e7982b3" providerId="ADAL" clId="{BCEA33ED-80C8-45DA-84CA-E58B367BC6D5}" dt="2025-07-07T17:16:10.765" v="2" actId="47"/>
        <pc:sldMkLst>
          <pc:docMk/>
          <pc:sldMk cId="1931122243" sldId="270"/>
        </pc:sldMkLst>
      </pc:sldChg>
      <pc:sldChg chg="del">
        <pc:chgData name="袖野 美穂/SODENO Miho" userId="013d5c9f-92f5-4661-9e91-da806e7982b3" providerId="ADAL" clId="{BCEA33ED-80C8-45DA-84CA-E58B367BC6D5}" dt="2025-07-07T17:16:13.150" v="4" actId="47"/>
        <pc:sldMkLst>
          <pc:docMk/>
          <pc:sldMk cId="1281285728" sldId="271"/>
        </pc:sldMkLst>
      </pc:sldChg>
      <pc:sldChg chg="del">
        <pc:chgData name="袖野 美穂/SODENO Miho" userId="013d5c9f-92f5-4661-9e91-da806e7982b3" providerId="ADAL" clId="{BCEA33ED-80C8-45DA-84CA-E58B367BC6D5}" dt="2025-07-07T17:16:13.987" v="6" actId="47"/>
        <pc:sldMkLst>
          <pc:docMk/>
          <pc:sldMk cId="2331672233" sldId="273"/>
        </pc:sldMkLst>
      </pc:sldChg>
      <pc:sldChg chg="del">
        <pc:chgData name="袖野 美穂/SODENO Miho" userId="013d5c9f-92f5-4661-9e91-da806e7982b3" providerId="ADAL" clId="{BCEA33ED-80C8-45DA-84CA-E58B367BC6D5}" dt="2025-07-07T17:16:09.939" v="0" actId="47"/>
        <pc:sldMkLst>
          <pc:docMk/>
          <pc:sldMk cId="2524183646" sldId="275"/>
        </pc:sldMkLst>
      </pc:sldChg>
      <pc:sldChg chg="del">
        <pc:chgData name="袖野 美穂/SODENO Miho" userId="013d5c9f-92f5-4661-9e91-da806e7982b3" providerId="ADAL" clId="{BCEA33ED-80C8-45DA-84CA-E58B367BC6D5}" dt="2025-07-07T17:16:11.947" v="3" actId="47"/>
        <pc:sldMkLst>
          <pc:docMk/>
          <pc:sldMk cId="3648385366" sldId="279"/>
        </pc:sldMkLst>
      </pc:sldChg>
      <pc:sldChg chg="del">
        <pc:chgData name="袖野 美穂/SODENO Miho" userId="013d5c9f-92f5-4661-9e91-da806e7982b3" providerId="ADAL" clId="{BCEA33ED-80C8-45DA-84CA-E58B367BC6D5}" dt="2025-07-07T17:16:13.611" v="5" actId="47"/>
        <pc:sldMkLst>
          <pc:docMk/>
          <pc:sldMk cId="127998114" sldId="28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479992-0F21-43C5-BA7F-0E120BA746B5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D6507C-F102-400E-9FB0-E718D8991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591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464166-24D6-BD56-45D3-D0E3EAFF4F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8B101F0-61C3-F262-27E8-C34AC27CA4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251" indent="0" algn="ctr">
              <a:buNone/>
              <a:defRPr sz="2000"/>
            </a:lvl2pPr>
            <a:lvl3pPr marL="914504" indent="0" algn="ctr">
              <a:buNone/>
              <a:defRPr sz="1801"/>
            </a:lvl3pPr>
            <a:lvl4pPr marL="1371754" indent="0" algn="ctr">
              <a:buNone/>
              <a:defRPr sz="1600"/>
            </a:lvl4pPr>
            <a:lvl5pPr marL="1829006" indent="0" algn="ctr">
              <a:buNone/>
              <a:defRPr sz="1600"/>
            </a:lvl5pPr>
            <a:lvl6pPr marL="2286257" indent="0" algn="ctr">
              <a:buNone/>
              <a:defRPr sz="1600"/>
            </a:lvl6pPr>
            <a:lvl7pPr marL="2743507" indent="0" algn="ctr">
              <a:buNone/>
              <a:defRPr sz="1600"/>
            </a:lvl7pPr>
            <a:lvl8pPr marL="3200760" indent="0" algn="ctr">
              <a:buNone/>
              <a:defRPr sz="1600"/>
            </a:lvl8pPr>
            <a:lvl9pPr marL="365801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873646-814D-139E-6EBC-D073E8684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27498A-25F5-EEDF-8800-A6ED18138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9EE125-A281-D6E6-C2CB-708E3B1F5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70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2AEE02-8DCC-D31E-9C3A-2B865A3A0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2592D87-4519-2A77-23C7-BF77B84B36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F3C872-9C8F-D98D-5B56-094CC4BB7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26A48A-1030-7439-157F-79A8E85DC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A90D9C-646E-735C-3901-3AFD8402C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793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A8E2D1E-0C26-1B93-9C71-F760F5A0EF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2D0B81-163A-619A-3E66-35672D120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29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569942-6514-EA79-0310-DD7B85AB0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C3043B-90EC-781B-0834-C6BD4C745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FDAFFE-DC5E-1A14-03AE-49F58B9C9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331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EE33C9-3A79-14B6-8829-F6515FBE3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1D083F-9BCC-3595-AE1A-ED073B3B60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F5A1A8-C56D-9B89-6CD3-1D0050D0F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BFAE5F-00C6-642B-A986-D3FD1F4CA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4BADFE-B366-034B-59F7-B3F32D2C2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708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698AC6-434B-C655-F844-0CE34F6E8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41"/>
            <a:ext cx="10515601" cy="2852737"/>
          </a:xfrm>
        </p:spPr>
        <p:txBody>
          <a:bodyPr anchor="b"/>
          <a:lstStyle>
            <a:lvl1pPr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38158F-CA22-188C-62EC-D4D856D37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1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>
                    <a:tint val="75000"/>
                  </a:schemeClr>
                </a:solidFill>
              </a:defRPr>
            </a:lvl1pPr>
            <a:lvl2pPr marL="45725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504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0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2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50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80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524BC6-6CAF-3716-52C8-DE451FCFD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6D899F-9B7A-FC89-1F38-E97237ECE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E77B89-2798-1C40-97DB-9DBC24B65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13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F88BD6-EA98-48B6-2C27-04A635E5F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5D0FEC-6E52-927E-E2BF-D4C29721F4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3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DA89C7D-957F-E13F-F6E1-4241384CA3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2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28B545-288E-AF55-1223-90321DED9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21AE36-EB79-8630-8E33-5F84D56A2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FD20AF-A0DE-83B5-B7CD-FB04BEA7B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41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B5474C-D259-AA88-4146-0E7A2CC1B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365128"/>
            <a:ext cx="10515601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53A3D25-A598-6255-2247-1CB293245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7" y="1681163"/>
            <a:ext cx="5157788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41BCCC0-2795-E539-B68B-DE110973A3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7" y="2505075"/>
            <a:ext cx="51577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F0E546-E806-FCFD-310A-35DC04EE9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199" y="1681163"/>
            <a:ext cx="5183189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414CC94-18E7-D95F-6C65-3FB4581C38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199" y="2505075"/>
            <a:ext cx="5183189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D52D1EE-9BE4-1205-8DCC-1DE2F5A83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53598D0-1A6B-670C-0BF0-18CD151F9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BAB580F-C925-340C-8CCA-A3FC926B1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86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7D32FE-3D50-FD48-FC87-A2599E2AD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E3A9190-3726-4C62-9FAD-953C1CA25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45A14A8-A3FE-EEBA-281C-12C44BEC9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5E39E7E-A737-8798-DE24-CF16C3792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330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D2E5DAD-DAA3-79E3-113B-80B35AB13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ED156AA-C8E1-13B5-6110-365D548DC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0E9B701-8EA4-F360-4B2C-3CDCFBD5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68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25B66D-E2A7-E9A0-B650-B75A01CA5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592B43-42DC-0A49-D02D-2850D4EBFB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>
              <a:defRPr sz="3200"/>
            </a:lvl1pPr>
            <a:lvl2pPr>
              <a:defRPr sz="2801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888D10-42CF-524B-AC75-1FCB8CBB12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C15839-D9C4-B3BB-CDC4-1D39BEC94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946F7F0-2DEC-9B50-3A5E-234AF3454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BA3AEE-4870-FB8A-894C-5AD678D8F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12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687730-23A1-3A73-FEE6-198F8163D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98D4E09-47B7-9550-3D68-BCB6E28EAB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51" indent="0">
              <a:buNone/>
              <a:defRPr sz="2801"/>
            </a:lvl2pPr>
            <a:lvl3pPr marL="914504" indent="0">
              <a:buNone/>
              <a:defRPr sz="2401"/>
            </a:lvl3pPr>
            <a:lvl4pPr marL="1371754" indent="0">
              <a:buNone/>
              <a:defRPr sz="2000"/>
            </a:lvl4pPr>
            <a:lvl5pPr marL="1829006" indent="0">
              <a:buNone/>
              <a:defRPr sz="2000"/>
            </a:lvl5pPr>
            <a:lvl6pPr marL="2286257" indent="0">
              <a:buNone/>
              <a:defRPr sz="2000"/>
            </a:lvl6pPr>
            <a:lvl7pPr marL="2743507" indent="0">
              <a:buNone/>
              <a:defRPr sz="2000"/>
            </a:lvl7pPr>
            <a:lvl8pPr marL="3200760" indent="0">
              <a:buNone/>
              <a:defRPr sz="2000"/>
            </a:lvl8pPr>
            <a:lvl9pPr marL="365801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B30E423-E91D-33BD-DB15-DB714B6291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F7ABA8A-511F-7F07-D15B-E2BF49CC3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513C96-2F02-04D2-1315-DAD071C57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C1AFED-7010-4214-6928-D65679E39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51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C4DDA90-2256-DA5A-432B-D75642FF2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8"/>
            <a:ext cx="1051560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80C4A4-CB0A-7557-0688-5F929D9CBB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6"/>
            <a:ext cx="1051560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B74CD4-E7B3-12EF-B0FB-F751E7BBB8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07A05F-3B7B-D6B4-82F5-BD4250443F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3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66ABC8-2CC7-8795-C985-82C1BCE4FA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177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504" rtl="0" eaLnBrk="1" latinLnBrk="0" hangingPunct="1">
        <a:lnSpc>
          <a:spcPct val="90000"/>
        </a:lnSpc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25" indent="-228625" algn="l" defTabSz="91450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1" kern="1200">
          <a:solidFill>
            <a:schemeClr val="tx1"/>
          </a:solidFill>
          <a:latin typeface="+mn-lt"/>
          <a:ea typeface="+mn-ea"/>
          <a:cs typeface="+mn-cs"/>
        </a:defRPr>
      </a:lvl1pPr>
      <a:lvl2pPr marL="6858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128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631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882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21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38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6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51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50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75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9006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25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50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76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801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A4A64E-6444-8C20-D23C-117F80B38719}"/>
              </a:ext>
            </a:extLst>
          </p:cNvPr>
          <p:cNvSpPr txBox="1"/>
          <p:nvPr/>
        </p:nvSpPr>
        <p:spPr>
          <a:xfrm>
            <a:off x="240534" y="169321"/>
            <a:ext cx="117109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[Additional File 2] The association between parental maltreatment behaviors and recognition status for overall maltreatment by parental sex: any types of maltreatment (Full result of Table 3)</a:t>
            </a: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BE4B9111-FC4F-C0F0-2D8B-7FC00CFA14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5892374"/>
              </p:ext>
            </p:extLst>
          </p:nvPr>
        </p:nvGraphicFramePr>
        <p:xfrm>
          <a:off x="111760" y="1141451"/>
          <a:ext cx="11968481" cy="4710152"/>
        </p:xfrm>
        <a:graphic>
          <a:graphicData uri="http://schemas.openxmlformats.org/drawingml/2006/table">
            <a:tbl>
              <a:tblPr firstRow="1" firstCol="1">
                <a:tableStyleId>{C083E6E3-FA7D-4D7B-A595-EF9225AFEA82}</a:tableStyleId>
              </a:tblPr>
              <a:tblGrid>
                <a:gridCol w="7097423">
                  <a:extLst>
                    <a:ext uri="{9D8B030D-6E8A-4147-A177-3AD203B41FA5}">
                      <a16:colId xmlns:a16="http://schemas.microsoft.com/office/drawing/2014/main" val="2219212099"/>
                    </a:ext>
                  </a:extLst>
                </a:gridCol>
                <a:gridCol w="2435529">
                  <a:extLst>
                    <a:ext uri="{9D8B030D-6E8A-4147-A177-3AD203B41FA5}">
                      <a16:colId xmlns:a16="http://schemas.microsoft.com/office/drawing/2014/main" val="2798895194"/>
                    </a:ext>
                  </a:extLst>
                </a:gridCol>
                <a:gridCol w="2435529">
                  <a:extLst>
                    <a:ext uri="{9D8B030D-6E8A-4147-A177-3AD203B41FA5}">
                      <a16:colId xmlns:a16="http://schemas.microsoft.com/office/drawing/2014/main" val="553297024"/>
                    </a:ext>
                  </a:extLst>
                </a:gridCol>
              </a:tblGrid>
              <a:tr h="435607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Factors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athers</a:t>
                      </a:r>
                      <a:b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R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 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95%CI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others</a:t>
                      </a:r>
                      <a:b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US" sz="2000" b="1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R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95%CI)</a:t>
                      </a:r>
                    </a:p>
                  </a:txBody>
                  <a:tcPr marL="3048" marR="3048" marT="3048" marB="0" anchor="ctr"/>
                </a:tc>
                <a:extLst>
                  <a:ext uri="{0D108BD9-81ED-4DB2-BD59-A6C34878D82A}">
                    <a16:rowId xmlns:a16="http://schemas.microsoft.com/office/drawing/2014/main" val="780399300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Unrecognition for </a:t>
                      </a:r>
                      <a:r>
                        <a:rPr lang="en-US" sz="2000" dirty="0"/>
                        <a:t>any types of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maltreatment </a:t>
                      </a:r>
                      <a:br>
                        <a:rPr lang="en-US" sz="2000" b="1" u="none" strike="noStrike" dirty="0">
                          <a:effectLst/>
                          <a:latin typeface="+mn-lt"/>
                        </a:rPr>
                      </a:b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(not recognized, compared by recognized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06 (1.43 - 2.99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88 (1.53 - 2.32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614314646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ge (</a:t>
                      </a:r>
                      <a:r>
                        <a:rPr lang="ja-JP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≧ </a:t>
                      </a:r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 years old, compared by &lt; 35 years old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5 (0.66 - 1.1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00 (0.85 - 1.19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18131076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ducation (college graduation and more, compared by less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92 (0.64 - 1.34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1 (0.67 - 0.96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814855489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Psychological distress (K6 score</a:t>
                      </a:r>
                      <a:r>
                        <a:rPr lang="en-US" sz="2000" b="1" u="none" strike="noStrike" baseline="30000" dirty="0">
                          <a:effectLst/>
                          <a:latin typeface="+mn-lt"/>
                        </a:rPr>
                        <a:t>3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ja-JP" altLang="en-US" sz="2000" b="1" u="none" strike="noStrike" dirty="0">
                          <a:effectLst/>
                          <a:latin typeface="+mn-lt"/>
                        </a:rPr>
                        <a:t>≧</a:t>
                      </a:r>
                      <a:r>
                        <a:rPr lang="en-US" altLang="ja-JP" sz="2000" b="1" u="none" strike="noStrike" dirty="0">
                          <a:effectLst/>
                          <a:latin typeface="+mn-lt"/>
                        </a:rPr>
                        <a:t>10, compared by &lt;10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Meiryo UI" panose="020B0604030504040204" pitchFamily="50" charset="-128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09 (1.58 - 2.74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80 (1.53 - 2.11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705421801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dverse childhood experience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10 (0.84 - 1.4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37 (1.16 - 1.62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56784281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Domestic violence 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experience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87 (1.41 - 2.47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91 (1.62 - 2.26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3502432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Age of the youngest child (</a:t>
                      </a:r>
                      <a:r>
                        <a:rPr lang="ja-JP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≧</a:t>
                      </a:r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1 year old, compared by &lt; 1 year old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4 (0.95 - 1.62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9 (1.10 - 1.51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48068342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Siblings with the youngest child 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48 (1.82 - 3.39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67 (2.23 - 3.19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57891250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NICU</a:t>
                      </a:r>
                      <a:r>
                        <a:rPr lang="en-US" sz="2000" b="1" u="none" strike="noStrike" baseline="30000" dirty="0">
                          <a:effectLst/>
                          <a:latin typeface="+mn-lt"/>
                        </a:rPr>
                        <a:t>4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admission of the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youngest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child (yes, compared by no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Meiryo UI" panose="020B0604030504040204" pitchFamily="50" charset="-128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30 (0.87 - 1.9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6 (0.63 - 1.18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82873248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080743F-BD0D-D962-7992-9F3FF5CF8BDA}"/>
              </a:ext>
            </a:extLst>
          </p:cNvPr>
          <p:cNvSpPr txBox="1"/>
          <p:nvPr/>
        </p:nvSpPr>
        <p:spPr>
          <a:xfrm>
            <a:off x="55880" y="5975291"/>
            <a:ext cx="12080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: </a:t>
            </a:r>
            <a:r>
              <a:rPr lang="en-US" dirty="0" err="1">
                <a:solidFill>
                  <a:srgbClr val="000000"/>
                </a:solidFill>
                <a:latin typeface="Calibri" panose="020F0502020204030204" pitchFamily="34" charset="0"/>
              </a:rPr>
              <a:t>a</a:t>
            </a:r>
            <a:r>
              <a:rPr lang="en-US" sz="18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</a:t>
            </a:r>
            <a:r>
              <a:rPr lang="en-US" sz="18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stands for adjusted prevalence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r</a:t>
            </a:r>
            <a:r>
              <a:rPr lang="en-US" sz="18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tio. 2: 95% CI stands for  </a:t>
            </a:r>
            <a:r>
              <a:rPr lang="en-US" sz="18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95% confidence interval. </a:t>
            </a:r>
            <a:r>
              <a:rPr lang="en-US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: NICU stands for neonatal intensive care unit. 4: K6 score stands for Kessler 6 scale score. </a:t>
            </a:r>
            <a:r>
              <a:rPr lang="en-US" altLang="ja-JP" dirty="0"/>
              <a:t>* p&lt;0.05 in Poisson regression analysis</a:t>
            </a:r>
          </a:p>
        </p:txBody>
      </p:sp>
    </p:spTree>
    <p:extLst>
      <p:ext uri="{BB962C8B-B14F-4D97-AF65-F5344CB8AC3E}">
        <p14:creationId xmlns:p14="http://schemas.microsoft.com/office/powerpoint/2010/main" val="988128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70</TotalTime>
  <Words>323</Words>
  <Application>Microsoft Office PowerPoint</Application>
  <PresentationFormat>ワイド画面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ho Sodeno</dc:creator>
  <cp:lastModifiedBy>袖野 美穂/SODENO Miho</cp:lastModifiedBy>
  <cp:revision>57</cp:revision>
  <dcterms:created xsi:type="dcterms:W3CDTF">2023-04-12T15:32:35Z</dcterms:created>
  <dcterms:modified xsi:type="dcterms:W3CDTF">2025-07-07T17:16:15Z</dcterms:modified>
</cp:coreProperties>
</file>